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56" r:id="rId2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10" autoAdjust="0"/>
    <p:restoredTop sz="94660"/>
  </p:normalViewPr>
  <p:slideViewPr>
    <p:cSldViewPr snapToGrid="0">
      <p:cViewPr varScale="1">
        <p:scale>
          <a:sx n="108" d="100"/>
          <a:sy n="108" d="100"/>
        </p:scale>
        <p:origin x="1482" y="1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7FF2B-52F1-4182-A6BB-DC861103194B}" type="datetimeFigureOut">
              <a:rPr lang="en-NZ" smtClean="0"/>
              <a:t>30/08/2024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65F1C-3EFD-40E1-9D26-7251ED509BA4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42288196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7FF2B-52F1-4182-A6BB-DC861103194B}" type="datetimeFigureOut">
              <a:rPr lang="en-NZ" smtClean="0"/>
              <a:t>30/08/2024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65F1C-3EFD-40E1-9D26-7251ED509BA4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6836239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7FF2B-52F1-4182-A6BB-DC861103194B}" type="datetimeFigureOut">
              <a:rPr lang="en-NZ" smtClean="0"/>
              <a:t>30/08/2024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65F1C-3EFD-40E1-9D26-7251ED509BA4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7703061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7FF2B-52F1-4182-A6BB-DC861103194B}" type="datetimeFigureOut">
              <a:rPr lang="en-NZ" smtClean="0"/>
              <a:t>30/08/2024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65F1C-3EFD-40E1-9D26-7251ED509BA4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0002250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7FF2B-52F1-4182-A6BB-DC861103194B}" type="datetimeFigureOut">
              <a:rPr lang="en-NZ" smtClean="0"/>
              <a:t>30/08/2024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65F1C-3EFD-40E1-9D26-7251ED509BA4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1101417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7FF2B-52F1-4182-A6BB-DC861103194B}" type="datetimeFigureOut">
              <a:rPr lang="en-NZ" smtClean="0"/>
              <a:t>30/08/2024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65F1C-3EFD-40E1-9D26-7251ED509BA4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3550975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7FF2B-52F1-4182-A6BB-DC861103194B}" type="datetimeFigureOut">
              <a:rPr lang="en-NZ" smtClean="0"/>
              <a:t>30/08/2024</a:t>
            </a:fld>
            <a:endParaRPr lang="en-NZ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65F1C-3EFD-40E1-9D26-7251ED509BA4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40107559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7FF2B-52F1-4182-A6BB-DC861103194B}" type="datetimeFigureOut">
              <a:rPr lang="en-NZ" smtClean="0"/>
              <a:t>30/08/2024</a:t>
            </a:fld>
            <a:endParaRPr lang="en-NZ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65F1C-3EFD-40E1-9D26-7251ED509BA4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5067304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7FF2B-52F1-4182-A6BB-DC861103194B}" type="datetimeFigureOut">
              <a:rPr lang="en-NZ" smtClean="0"/>
              <a:t>30/08/2024</a:t>
            </a:fld>
            <a:endParaRPr lang="en-NZ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65F1C-3EFD-40E1-9D26-7251ED509BA4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8399142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7FF2B-52F1-4182-A6BB-DC861103194B}" type="datetimeFigureOut">
              <a:rPr lang="en-NZ" smtClean="0"/>
              <a:t>30/08/2024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65F1C-3EFD-40E1-9D26-7251ED509BA4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0378444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7FF2B-52F1-4182-A6BB-DC861103194B}" type="datetimeFigureOut">
              <a:rPr lang="en-NZ" smtClean="0"/>
              <a:t>30/08/2024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65F1C-3EFD-40E1-9D26-7251ED509BA4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693023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47FF2B-52F1-4182-A6BB-DC861103194B}" type="datetimeFigureOut">
              <a:rPr lang="en-NZ" smtClean="0"/>
              <a:t>30/08/2024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865F1C-3EFD-40E1-9D26-7251ED509BA4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41642868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" name="TextBox 63">
            <a:extLst>
              <a:ext uri="{FF2B5EF4-FFF2-40B4-BE49-F238E27FC236}">
                <a16:creationId xmlns:a16="http://schemas.microsoft.com/office/drawing/2014/main" id="{3B90A728-0F13-26E6-C849-DA1AF0BD294F}"/>
              </a:ext>
            </a:extLst>
          </p:cNvPr>
          <p:cNvSpPr txBox="1"/>
          <p:nvPr/>
        </p:nvSpPr>
        <p:spPr>
          <a:xfrm>
            <a:off x="245802" y="103874"/>
            <a:ext cx="713319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NZ" dirty="0"/>
              <a:t>Supplemental Figure 2 – mean (SEM) IESR responses to study treatments. Time 0 </a:t>
            </a:r>
            <a:r>
              <a:rPr lang="en-NZ"/>
              <a:t>is immediately pre-dose. </a:t>
            </a:r>
            <a:endParaRPr lang="en-NZ" dirty="0"/>
          </a:p>
        </p:txBody>
      </p:sp>
      <p:grpSp>
        <p:nvGrpSpPr>
          <p:cNvPr id="22" name="Group 21">
            <a:extLst>
              <a:ext uri="{FF2B5EF4-FFF2-40B4-BE49-F238E27FC236}">
                <a16:creationId xmlns:a16="http://schemas.microsoft.com/office/drawing/2014/main" id="{BA17C6B8-4ACA-4EC9-6069-8360E5E9EF9D}"/>
              </a:ext>
            </a:extLst>
          </p:cNvPr>
          <p:cNvGrpSpPr/>
          <p:nvPr/>
        </p:nvGrpSpPr>
        <p:grpSpPr>
          <a:xfrm>
            <a:off x="0" y="926612"/>
            <a:ext cx="6895125" cy="3366746"/>
            <a:chOff x="-220688" y="216806"/>
            <a:chExt cx="6895125" cy="3366746"/>
          </a:xfrm>
        </p:grpSpPr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BC974062-2271-9CA2-AE44-14D3BC5580C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434372" y="216806"/>
              <a:ext cx="3201467" cy="3120390"/>
            </a:xfrm>
            <a:prstGeom prst="rect">
              <a:avLst/>
            </a:prstGeom>
          </p:spPr>
        </p:pic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745229A6-401B-E2F2-E5E8-F24315449B04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50027" y="216806"/>
              <a:ext cx="3201467" cy="3121457"/>
            </a:xfrm>
            <a:prstGeom prst="rect">
              <a:avLst/>
            </a:prstGeom>
          </p:spPr>
        </p:pic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2119CC93-E8C8-754D-B06A-E319DA75657C}"/>
                </a:ext>
              </a:extLst>
            </p:cNvPr>
            <p:cNvSpPr txBox="1"/>
            <p:nvPr/>
          </p:nvSpPr>
          <p:spPr>
            <a:xfrm>
              <a:off x="-220688" y="1609763"/>
              <a:ext cx="80049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NZ" sz="1400" b="1" dirty="0"/>
                <a:t>20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756828C8-E6BC-21D7-D995-CBE352BDFDB7}"/>
                </a:ext>
              </a:extLst>
            </p:cNvPr>
            <p:cNvSpPr txBox="1"/>
            <p:nvPr/>
          </p:nvSpPr>
          <p:spPr>
            <a:xfrm>
              <a:off x="-220688" y="2715759"/>
              <a:ext cx="80049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NZ" sz="1400" b="1" dirty="0"/>
                <a:t>0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EDDE041B-3961-2B11-B957-0B997393223B}"/>
                </a:ext>
              </a:extLst>
            </p:cNvPr>
            <p:cNvSpPr txBox="1"/>
            <p:nvPr/>
          </p:nvSpPr>
          <p:spPr>
            <a:xfrm>
              <a:off x="-220688" y="384427"/>
              <a:ext cx="80049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NZ" sz="1400" b="1" dirty="0"/>
                <a:t>50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DA0F9C30-093E-C841-2207-C5D5561CED4F}"/>
                </a:ext>
              </a:extLst>
            </p:cNvPr>
            <p:cNvSpPr txBox="1"/>
            <p:nvPr/>
          </p:nvSpPr>
          <p:spPr>
            <a:xfrm>
              <a:off x="-220688" y="2062041"/>
              <a:ext cx="80049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NZ" sz="1400" b="1" dirty="0"/>
                <a:t>10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76A79EC2-6042-3419-CF27-7108EE886EAB}"/>
                </a:ext>
              </a:extLst>
            </p:cNvPr>
            <p:cNvSpPr txBox="1"/>
            <p:nvPr/>
          </p:nvSpPr>
          <p:spPr>
            <a:xfrm>
              <a:off x="-220688" y="1177375"/>
              <a:ext cx="80049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NZ" sz="1400" b="1" dirty="0"/>
                <a:t>30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73A90A88-54F9-01D5-754D-8DE2304C4A73}"/>
                </a:ext>
              </a:extLst>
            </p:cNvPr>
            <p:cNvSpPr txBox="1"/>
            <p:nvPr/>
          </p:nvSpPr>
          <p:spPr>
            <a:xfrm>
              <a:off x="-217140" y="738848"/>
              <a:ext cx="80049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NZ" sz="1400" b="1" dirty="0"/>
                <a:t>40</a:t>
              </a:r>
            </a:p>
          </p:txBody>
        </p:sp>
        <p:grpSp>
          <p:nvGrpSpPr>
            <p:cNvPr id="21" name="Group 20">
              <a:extLst>
                <a:ext uri="{FF2B5EF4-FFF2-40B4-BE49-F238E27FC236}">
                  <a16:creationId xmlns:a16="http://schemas.microsoft.com/office/drawing/2014/main" id="{F3574967-69D6-A810-89FB-999B18445EAE}"/>
                </a:ext>
              </a:extLst>
            </p:cNvPr>
            <p:cNvGrpSpPr/>
            <p:nvPr/>
          </p:nvGrpSpPr>
          <p:grpSpPr>
            <a:xfrm>
              <a:off x="436454" y="331751"/>
              <a:ext cx="6237983" cy="3251801"/>
              <a:chOff x="436454" y="331751"/>
              <a:chExt cx="6237983" cy="3251801"/>
            </a:xfrm>
          </p:grpSpPr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9B2794CE-81E1-27F6-4A6A-52B184B2D225}"/>
                  </a:ext>
                </a:extLst>
              </p:cNvPr>
              <p:cNvSpPr txBox="1"/>
              <p:nvPr/>
            </p:nvSpPr>
            <p:spPr>
              <a:xfrm>
                <a:off x="634674" y="331751"/>
                <a:ext cx="2810283" cy="30777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NZ" sz="1400" b="1" dirty="0"/>
                  <a:t>non-comorbid PTSD</a:t>
                </a:r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360B423C-3EB2-1A9F-31A1-91C60B984795}"/>
                  </a:ext>
                </a:extLst>
              </p:cNvPr>
              <p:cNvSpPr txBox="1"/>
              <p:nvPr/>
            </p:nvSpPr>
            <p:spPr>
              <a:xfrm>
                <a:off x="3732290" y="331751"/>
                <a:ext cx="2810283" cy="30777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NZ" sz="1400" b="1" dirty="0"/>
                  <a:t>comorbid PTSD/TRD</a:t>
                </a:r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2371A647-251C-65B0-DD37-7D5DBF8B0A18}"/>
                  </a:ext>
                </a:extLst>
              </p:cNvPr>
              <p:cNvSpPr txBox="1"/>
              <p:nvPr/>
            </p:nvSpPr>
            <p:spPr>
              <a:xfrm>
                <a:off x="436454" y="2957083"/>
                <a:ext cx="360000" cy="28800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NZ" sz="1400" b="1" dirty="0"/>
                  <a:t>0</a:t>
                </a:r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0325ACD0-F438-2586-1858-A8FAD9193948}"/>
                  </a:ext>
                </a:extLst>
              </p:cNvPr>
              <p:cNvSpPr txBox="1"/>
              <p:nvPr/>
            </p:nvSpPr>
            <p:spPr>
              <a:xfrm>
                <a:off x="951373" y="2957083"/>
                <a:ext cx="720000" cy="28800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NZ" sz="1400" b="1" dirty="0"/>
                  <a:t>1</a:t>
                </a: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35BDD92B-BF1A-C426-4D66-A0C1ECA38A65}"/>
                  </a:ext>
                </a:extLst>
              </p:cNvPr>
              <p:cNvSpPr txBox="1"/>
              <p:nvPr/>
            </p:nvSpPr>
            <p:spPr>
              <a:xfrm>
                <a:off x="1648756" y="2957083"/>
                <a:ext cx="720000" cy="28800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NZ" sz="1400" b="1" dirty="0"/>
                  <a:t>2</a:t>
                </a:r>
              </a:p>
            </p:txBody>
          </p:sp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6BEF93EA-D1A3-ABE1-0F09-3B829023BA91}"/>
                  </a:ext>
                </a:extLst>
              </p:cNvPr>
              <p:cNvSpPr txBox="1"/>
              <p:nvPr/>
            </p:nvSpPr>
            <p:spPr>
              <a:xfrm>
                <a:off x="2345931" y="2957083"/>
                <a:ext cx="720000" cy="28800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NZ" sz="1400" b="1" dirty="0"/>
                  <a:t>24</a:t>
                </a:r>
              </a:p>
            </p:txBody>
          </p:sp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F7AB1F33-FF9A-03A4-24B7-790671BABC7A}"/>
                  </a:ext>
                </a:extLst>
              </p:cNvPr>
              <p:cNvSpPr txBox="1"/>
              <p:nvPr/>
            </p:nvSpPr>
            <p:spPr>
              <a:xfrm>
                <a:off x="3046613" y="2957083"/>
                <a:ext cx="540000" cy="28800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NZ" sz="1400" b="1" dirty="0"/>
                  <a:t>168</a:t>
                </a:r>
              </a:p>
            </p:txBody>
          </p:sp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553504CD-E048-EC77-F401-BCD902615EC3}"/>
                  </a:ext>
                </a:extLst>
              </p:cNvPr>
              <p:cNvSpPr txBox="1"/>
              <p:nvPr/>
            </p:nvSpPr>
            <p:spPr>
              <a:xfrm>
                <a:off x="643317" y="3275775"/>
                <a:ext cx="2716576" cy="30777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NZ" sz="1400" b="1" dirty="0"/>
                  <a:t>time (h)</a:t>
                </a:r>
              </a:p>
            </p:txBody>
          </p:sp>
          <p:sp>
            <p:nvSpPr>
              <p:cNvPr id="50" name="TextBox 49">
                <a:extLst>
                  <a:ext uri="{FF2B5EF4-FFF2-40B4-BE49-F238E27FC236}">
                    <a16:creationId xmlns:a16="http://schemas.microsoft.com/office/drawing/2014/main" id="{995FF551-D4AC-8EA2-107D-91E266309871}"/>
                  </a:ext>
                </a:extLst>
              </p:cNvPr>
              <p:cNvSpPr txBox="1"/>
              <p:nvPr/>
            </p:nvSpPr>
            <p:spPr>
              <a:xfrm>
                <a:off x="3524278" y="2957083"/>
                <a:ext cx="360000" cy="28800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NZ" sz="1400" b="1" dirty="0"/>
                  <a:t>0</a:t>
                </a:r>
              </a:p>
            </p:txBody>
          </p:sp>
          <p:sp>
            <p:nvSpPr>
              <p:cNvPr id="51" name="TextBox 50">
                <a:extLst>
                  <a:ext uri="{FF2B5EF4-FFF2-40B4-BE49-F238E27FC236}">
                    <a16:creationId xmlns:a16="http://schemas.microsoft.com/office/drawing/2014/main" id="{90DA9392-8B9F-E0D6-57C7-767538300237}"/>
                  </a:ext>
                </a:extLst>
              </p:cNvPr>
              <p:cNvSpPr txBox="1"/>
              <p:nvPr/>
            </p:nvSpPr>
            <p:spPr>
              <a:xfrm>
                <a:off x="4039197" y="2957083"/>
                <a:ext cx="720000" cy="28800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NZ" sz="1400" b="1" dirty="0"/>
                  <a:t>1</a:t>
                </a:r>
              </a:p>
            </p:txBody>
          </p:sp>
          <p:sp>
            <p:nvSpPr>
              <p:cNvPr id="52" name="TextBox 51">
                <a:extLst>
                  <a:ext uri="{FF2B5EF4-FFF2-40B4-BE49-F238E27FC236}">
                    <a16:creationId xmlns:a16="http://schemas.microsoft.com/office/drawing/2014/main" id="{0E9BF2EC-E3E1-089A-1008-22518705A834}"/>
                  </a:ext>
                </a:extLst>
              </p:cNvPr>
              <p:cNvSpPr txBox="1"/>
              <p:nvPr/>
            </p:nvSpPr>
            <p:spPr>
              <a:xfrm>
                <a:off x="4736580" y="2957083"/>
                <a:ext cx="720000" cy="28800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NZ" sz="1400" b="1" dirty="0"/>
                  <a:t>2</a:t>
                </a:r>
              </a:p>
            </p:txBody>
          </p:sp>
          <p:sp>
            <p:nvSpPr>
              <p:cNvPr id="53" name="TextBox 52">
                <a:extLst>
                  <a:ext uri="{FF2B5EF4-FFF2-40B4-BE49-F238E27FC236}">
                    <a16:creationId xmlns:a16="http://schemas.microsoft.com/office/drawing/2014/main" id="{1A9A3D0E-755E-C3CA-B0F7-AD770B7179B8}"/>
                  </a:ext>
                </a:extLst>
              </p:cNvPr>
              <p:cNvSpPr txBox="1"/>
              <p:nvPr/>
            </p:nvSpPr>
            <p:spPr>
              <a:xfrm>
                <a:off x="5433755" y="2957083"/>
                <a:ext cx="720000" cy="28800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NZ" sz="1400" b="1" dirty="0"/>
                  <a:t>24</a:t>
                </a:r>
              </a:p>
            </p:txBody>
          </p:sp>
          <p:sp>
            <p:nvSpPr>
              <p:cNvPr id="54" name="TextBox 53">
                <a:extLst>
                  <a:ext uri="{FF2B5EF4-FFF2-40B4-BE49-F238E27FC236}">
                    <a16:creationId xmlns:a16="http://schemas.microsoft.com/office/drawing/2014/main" id="{06B1BEF5-9AF7-A689-7F52-E1BAD2060FD2}"/>
                  </a:ext>
                </a:extLst>
              </p:cNvPr>
              <p:cNvSpPr txBox="1"/>
              <p:nvPr/>
            </p:nvSpPr>
            <p:spPr>
              <a:xfrm>
                <a:off x="6134437" y="2957083"/>
                <a:ext cx="540000" cy="28800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NZ" sz="1400" b="1" dirty="0"/>
                  <a:t>168</a:t>
                </a:r>
              </a:p>
            </p:txBody>
          </p:sp>
          <p:sp>
            <p:nvSpPr>
              <p:cNvPr id="55" name="TextBox 54">
                <a:extLst>
                  <a:ext uri="{FF2B5EF4-FFF2-40B4-BE49-F238E27FC236}">
                    <a16:creationId xmlns:a16="http://schemas.microsoft.com/office/drawing/2014/main" id="{22817041-F842-2EEF-2831-457816C7F1C7}"/>
                  </a:ext>
                </a:extLst>
              </p:cNvPr>
              <p:cNvSpPr txBox="1"/>
              <p:nvPr/>
            </p:nvSpPr>
            <p:spPr>
              <a:xfrm>
                <a:off x="3731141" y="3275775"/>
                <a:ext cx="2716576" cy="30777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NZ" sz="1400" b="1" dirty="0"/>
                  <a:t>time (h)</a:t>
                </a:r>
              </a:p>
            </p:txBody>
          </p:sp>
          <p:sp>
            <p:nvSpPr>
              <p:cNvPr id="20" name="Rectangle 19">
                <a:extLst>
                  <a:ext uri="{FF2B5EF4-FFF2-40B4-BE49-F238E27FC236}">
                    <a16:creationId xmlns:a16="http://schemas.microsoft.com/office/drawing/2014/main" id="{0A628575-B8D5-76D9-BE39-C10577D982DA}"/>
                  </a:ext>
                </a:extLst>
              </p:cNvPr>
              <p:cNvSpPr/>
              <p:nvPr/>
            </p:nvSpPr>
            <p:spPr>
              <a:xfrm>
                <a:off x="1146972" y="692204"/>
                <a:ext cx="1298516" cy="594336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NZ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0250238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23</TotalTime>
  <Words>50</Words>
  <Application>Microsoft Office PowerPoint</Application>
  <PresentationFormat>A4 Paper (210x297 mm)</PresentationFormat>
  <Paragraphs>2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eil McNaughton</dc:creator>
  <cp:lastModifiedBy>Ben Beaglehole</cp:lastModifiedBy>
  <cp:revision>13</cp:revision>
  <dcterms:created xsi:type="dcterms:W3CDTF">2024-08-12T03:49:53Z</dcterms:created>
  <dcterms:modified xsi:type="dcterms:W3CDTF">2024-08-30T02:38:19Z</dcterms:modified>
</cp:coreProperties>
</file>